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0EF000-BD3F-45EB-9213-FA7ED72FB3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44C7D-72A9-411F-B65A-984F1C34F7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DA8007-F312-4697-848B-6ADB68F457E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2A94D-89DB-4D95-8A91-96744ABD9BF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E67EFD-F550-4CE4-B5C4-489EA3E74D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A9917A-FC5E-41DB-9381-5BF19DBADC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11504B-8353-4F68-A676-1002EEDA5D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F46D88-FE42-447A-A71B-FAD3D32CB5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E25628-FA31-4B53-A740-03EDC20960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DD72EF-6F9D-4638-AB8E-3C4C0FDD34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618EE8-9475-4279-9F29-4BA6C3BBC8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856832-CA20-45ED-B649-69ADF2157B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EE3680-A151-4B6B-9BA1-94F1FCCD9D8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94"/>
          <p:cNvSpPr/>
          <p:nvPr/>
        </p:nvSpPr>
        <p:spPr>
          <a:xfrm>
            <a:off x="685800" y="1676520"/>
            <a:ext cx="5638680" cy="4651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22"/>
          <p:cNvSpPr/>
          <p:nvPr/>
        </p:nvSpPr>
        <p:spPr>
          <a:xfrm>
            <a:off x="2027160" y="7005600"/>
            <a:ext cx="4245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3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oup 43"/>
          <p:cNvGrpSpPr/>
          <p:nvPr/>
        </p:nvGrpSpPr>
        <p:grpSpPr>
          <a:xfrm>
            <a:off x="739800" y="2077920"/>
            <a:ext cx="2986200" cy="1871640"/>
            <a:chOff x="739800" y="2077920"/>
            <a:chExt cx="2986200" cy="1871640"/>
          </a:xfrm>
        </p:grpSpPr>
        <p:sp>
          <p:nvSpPr>
            <p:cNvPr id="44" name="TextBox 52"/>
            <p:cNvSpPr/>
            <p:nvPr/>
          </p:nvSpPr>
          <p:spPr>
            <a:xfrm>
              <a:off x="739800" y="3416400"/>
              <a:ext cx="4251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 Narrow"/>
                </a:rPr>
                <a:t>177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 Narrow"/>
                </a:rPr>
                <a:t>b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5" name="Picture 2" descr="C:\Users\a0isma02\Desktop\New adds\Vitamine D\Final things Vit D_June 30, 2015\To Mariusz (Oct. 28, 2015)\new\Final\Picture1.tif"/>
            <p:cNvPicPr/>
            <p:nvPr/>
          </p:nvPicPr>
          <p:blipFill>
            <a:blip r:embed="rId1"/>
            <a:srcRect l="23127" t="22104" r="8843" b="0"/>
            <a:stretch/>
          </p:blipFill>
          <p:spPr>
            <a:xfrm>
              <a:off x="1291680" y="2473920"/>
              <a:ext cx="2152440" cy="147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Box 45"/>
            <p:cNvSpPr/>
            <p:nvPr/>
          </p:nvSpPr>
          <p:spPr>
            <a:xfrm>
              <a:off x="1387440" y="2284200"/>
              <a:ext cx="517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Box 46"/>
            <p:cNvSpPr/>
            <p:nvPr/>
          </p:nvSpPr>
          <p:spPr>
            <a:xfrm>
              <a:off x="1635120" y="2277720"/>
              <a:ext cx="561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NC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Box 47"/>
            <p:cNvSpPr/>
            <p:nvPr/>
          </p:nvSpPr>
          <p:spPr>
            <a:xfrm>
              <a:off x="2054880" y="2279520"/>
              <a:ext cx="612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ptima"/>
                </a:rPr>
                <a:t>ESD3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48"/>
            <p:cNvSpPr/>
            <p:nvPr/>
          </p:nvSpPr>
          <p:spPr>
            <a:xfrm>
              <a:off x="2403720" y="2276280"/>
              <a:ext cx="533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Narrow"/>
                  <a:ea typeface="Optima"/>
                </a:rPr>
                <a:t>HSC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49"/>
            <p:cNvSpPr/>
            <p:nvPr/>
          </p:nvSpPr>
          <p:spPr>
            <a:xfrm>
              <a:off x="2689920" y="2280960"/>
              <a:ext cx="608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ptima"/>
                </a:rPr>
                <a:t>-cD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50"/>
            <p:cNvSpPr/>
            <p:nvPr/>
          </p:nvSpPr>
          <p:spPr>
            <a:xfrm>
              <a:off x="3089520" y="226980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ptima"/>
                </a:rPr>
                <a:t>-R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2" name="Straight Arrow Connector 51"/>
            <p:cNvCxnSpPr/>
            <p:nvPr/>
          </p:nvCxnSpPr>
          <p:spPr>
            <a:xfrm>
              <a:off x="1091880" y="3557160"/>
              <a:ext cx="19908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53" name="TextBox 53"/>
            <p:cNvSpPr/>
            <p:nvPr/>
          </p:nvSpPr>
          <p:spPr>
            <a:xfrm>
              <a:off x="1725480" y="2077920"/>
              <a:ext cx="1546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 Narrow"/>
                </a:rPr>
                <a:t>Murine VD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4" name="Group 3"/>
          <p:cNvGrpSpPr/>
          <p:nvPr/>
        </p:nvGrpSpPr>
        <p:grpSpPr>
          <a:xfrm>
            <a:off x="3819600" y="1919160"/>
            <a:ext cx="3029040" cy="2132280"/>
            <a:chOff x="3819600" y="1919160"/>
            <a:chExt cx="3029040" cy="2132280"/>
          </a:xfrm>
        </p:grpSpPr>
        <p:grpSp>
          <p:nvGrpSpPr>
            <p:cNvPr id="55" name="Group 1"/>
            <p:cNvGrpSpPr/>
            <p:nvPr/>
          </p:nvGrpSpPr>
          <p:grpSpPr>
            <a:xfrm>
              <a:off x="3860640" y="1919160"/>
              <a:ext cx="2438640" cy="2132280"/>
              <a:chOff x="3860640" y="1919160"/>
              <a:chExt cx="2438640" cy="2132280"/>
            </a:xfrm>
          </p:grpSpPr>
          <p:grpSp>
            <p:nvGrpSpPr>
              <p:cNvPr id="56" name="Group 29"/>
              <p:cNvGrpSpPr/>
              <p:nvPr/>
            </p:nvGrpSpPr>
            <p:grpSpPr>
              <a:xfrm>
                <a:off x="3860640" y="1919160"/>
                <a:ext cx="2438640" cy="2050200"/>
                <a:chOff x="3860640" y="1919160"/>
                <a:chExt cx="2438640" cy="2050200"/>
              </a:xfrm>
            </p:grpSpPr>
            <p:sp>
              <p:nvSpPr>
                <p:cNvPr id="57" name="TextBox 16"/>
                <p:cNvSpPr/>
                <p:nvPr/>
              </p:nvSpPr>
              <p:spPr>
                <a:xfrm>
                  <a:off x="3987720" y="1919160"/>
                  <a:ext cx="19306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, 25- dihydroxyvitamin D3[M]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8" name="Group 10"/>
                <p:cNvGrpSpPr/>
                <p:nvPr/>
              </p:nvGrpSpPr>
              <p:grpSpPr>
                <a:xfrm>
                  <a:off x="3860640" y="2374200"/>
                  <a:ext cx="1522800" cy="1248120"/>
                  <a:chOff x="3860640" y="2374200"/>
                  <a:chExt cx="1522800" cy="1248120"/>
                </a:xfrm>
              </p:grpSpPr>
              <p:pic>
                <p:nvPicPr>
                  <p:cNvPr id="59" name="Picture 4" descr=""/>
                  <p:cNvPicPr/>
                  <p:nvPr/>
                </p:nvPicPr>
                <p:blipFill>
                  <a:blip r:embed="rId2"/>
                  <a:srcRect l="13278" t="31208" r="42866" b="14678"/>
                  <a:stretch/>
                </p:blipFill>
                <p:spPr>
                  <a:xfrm>
                    <a:off x="3860640" y="2791440"/>
                    <a:ext cx="1522800" cy="39852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  <p:pic>
                <p:nvPicPr>
                  <p:cNvPr id="60" name="Picture 3" descr=""/>
                  <p:cNvPicPr/>
                  <p:nvPr/>
                </p:nvPicPr>
                <p:blipFill>
                  <a:blip r:embed="rId3"/>
                  <a:srcRect l="11793" t="8299" r="42603" b="34717"/>
                  <a:stretch/>
                </p:blipFill>
                <p:spPr>
                  <a:xfrm>
                    <a:off x="3860640" y="2374200"/>
                    <a:ext cx="1522800" cy="39852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  <p:pic>
                <p:nvPicPr>
                  <p:cNvPr id="61" name="Picture 2" descr=""/>
                  <p:cNvPicPr/>
                  <p:nvPr/>
                </p:nvPicPr>
                <p:blipFill>
                  <a:blip r:embed="rId4"/>
                  <a:srcRect l="3207" t="37791" r="53681" b="9419"/>
                  <a:stretch/>
                </p:blipFill>
                <p:spPr>
                  <a:xfrm>
                    <a:off x="3860640" y="3215160"/>
                    <a:ext cx="1522800" cy="4071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grpSp>
            <p:sp>
              <p:nvSpPr>
                <p:cNvPr id="62" name="Straight Connector 50"/>
                <p:cNvSpPr/>
                <p:nvPr/>
              </p:nvSpPr>
              <p:spPr>
                <a:xfrm flipH="1">
                  <a:off x="4234680" y="2152440"/>
                  <a:ext cx="91440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TextBox 25"/>
                <p:cNvSpPr/>
                <p:nvPr/>
              </p:nvSpPr>
              <p:spPr>
                <a:xfrm>
                  <a:off x="5335560" y="2471760"/>
                  <a:ext cx="9637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pMAPK42/44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TextBox 26"/>
                <p:cNvSpPr/>
                <p:nvPr/>
              </p:nvSpPr>
              <p:spPr>
                <a:xfrm>
                  <a:off x="5335560" y="3287880"/>
                  <a:ext cx="9129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pAKTser473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TextBox 27"/>
                <p:cNvSpPr/>
                <p:nvPr/>
              </p:nvSpPr>
              <p:spPr>
                <a:xfrm>
                  <a:off x="5342040" y="2870280"/>
                  <a:ext cx="9572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MAPK42/44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TextBox 28"/>
                <p:cNvSpPr/>
                <p:nvPr/>
              </p:nvSpPr>
              <p:spPr>
                <a:xfrm>
                  <a:off x="5327640" y="3723120"/>
                  <a:ext cx="6508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AKT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67" name="Picture 3" descr=""/>
              <p:cNvPicPr/>
              <p:nvPr/>
            </p:nvPicPr>
            <p:blipFill>
              <a:blip r:embed="rId5"/>
              <a:srcRect l="7228" t="25586" r="41357" b="16073"/>
              <a:stretch/>
            </p:blipFill>
            <p:spPr>
              <a:xfrm>
                <a:off x="3860640" y="3644280"/>
                <a:ext cx="1522800" cy="40716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</p:grpSp>
        <p:sp>
          <p:nvSpPr>
            <p:cNvPr id="68" name="TextBox 54"/>
            <p:cNvSpPr/>
            <p:nvPr/>
          </p:nvSpPr>
          <p:spPr>
            <a:xfrm>
              <a:off x="3819600" y="2163600"/>
              <a:ext cx="3029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ptima"/>
                </a:rPr>
                <a:t>Ctrl  10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Times New Roman"/>
                  <a:ea typeface="Optima"/>
                </a:rPr>
                <a:t>‒10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ptima"/>
                </a:rPr>
                <a:t> 10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Times New Roman"/>
                  <a:ea typeface="Optima"/>
                </a:rPr>
                <a:t>‒9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ptima"/>
                </a:rPr>
                <a:t> 10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Times New Roman"/>
                  <a:ea typeface="Optima"/>
                </a:rPr>
                <a:t>‒8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ptima"/>
                </a:rPr>
                <a:t> 10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Times New Roman"/>
                  <a:ea typeface="Optima"/>
                </a:rPr>
                <a:t>‒7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ptima"/>
                </a:rPr>
                <a:t>FB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9" name="TextBox 12"/>
          <p:cNvSpPr/>
          <p:nvPr/>
        </p:nvSpPr>
        <p:spPr>
          <a:xfrm>
            <a:off x="933480" y="1801800"/>
            <a:ext cx="58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12"/>
          <p:cNvSpPr/>
          <p:nvPr/>
        </p:nvSpPr>
        <p:spPr>
          <a:xfrm>
            <a:off x="3695760" y="1803240"/>
            <a:ext cx="58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1" name="Group 2"/>
          <p:cNvGrpSpPr/>
          <p:nvPr/>
        </p:nvGrpSpPr>
        <p:grpSpPr>
          <a:xfrm>
            <a:off x="1407960" y="3508200"/>
            <a:ext cx="3965760" cy="2548440"/>
            <a:chOff x="1407960" y="3508200"/>
            <a:chExt cx="3965760" cy="2548440"/>
          </a:xfrm>
        </p:grpSpPr>
        <p:pic>
          <p:nvPicPr>
            <p:cNvPr id="72" name="Chart 34" descr=""/>
            <p:cNvPicPr/>
            <p:nvPr/>
          </p:nvPicPr>
          <p:blipFill>
            <a:blip r:embed="rId6"/>
            <a:stretch/>
          </p:blipFill>
          <p:spPr>
            <a:xfrm>
              <a:off x="1407960" y="3508200"/>
              <a:ext cx="3965760" cy="2273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3" name="TextBox 33"/>
            <p:cNvSpPr/>
            <p:nvPr/>
          </p:nvSpPr>
          <p:spPr>
            <a:xfrm>
              <a:off x="2176200" y="5549760"/>
              <a:ext cx="3029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ptima"/>
                </a:rPr>
                <a:t>Vehicle        10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Times New Roman"/>
                  <a:ea typeface="Optima"/>
                </a:rPr>
                <a:t>‒10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ptima"/>
                </a:rPr>
                <a:t>          10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Times New Roman"/>
                  <a:ea typeface="Optima"/>
                </a:rPr>
                <a:t>‒9                 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ptima"/>
                </a:rPr>
                <a:t>10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Times New Roman"/>
                  <a:ea typeface="Optima"/>
                </a:rPr>
                <a:t>‒8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Optima"/>
                </a:rPr>
                <a:t>            10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Times New Roman"/>
                  <a:ea typeface="Optima"/>
                </a:rPr>
                <a:t>‒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Box 34"/>
            <p:cNvSpPr/>
            <p:nvPr/>
          </p:nvSpPr>
          <p:spPr>
            <a:xfrm>
              <a:off x="2296800" y="5810400"/>
              <a:ext cx="2760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, 25- dihydroxyvitamin D3[M]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Box 35"/>
            <p:cNvSpPr/>
            <p:nvPr/>
          </p:nvSpPr>
          <p:spPr>
            <a:xfrm>
              <a:off x="3519360" y="4355280"/>
              <a:ext cx="269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Box 36"/>
            <p:cNvSpPr/>
            <p:nvPr/>
          </p:nvSpPr>
          <p:spPr>
            <a:xfrm>
              <a:off x="4150440" y="4321800"/>
              <a:ext cx="268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Box 37"/>
            <p:cNvSpPr/>
            <p:nvPr/>
          </p:nvSpPr>
          <p:spPr>
            <a:xfrm>
              <a:off x="4736520" y="4382280"/>
              <a:ext cx="268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8" name="TextBox 12"/>
          <p:cNvSpPr/>
          <p:nvPr/>
        </p:nvSpPr>
        <p:spPr>
          <a:xfrm>
            <a:off x="932040" y="4299120"/>
            <a:ext cx="587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0-28T21:32:08Z</dcterms:created>
  <dc:creator>Ismail,Ahmed Abdelbaset Ahmed Attia</dc:creator>
  <dc:description/>
  <dc:language>en-US</dc:language>
  <cp:lastModifiedBy>Mariusz Ratajczak</cp:lastModifiedBy>
  <cp:lastPrinted>2016-02-11T16:12:03Z</cp:lastPrinted>
  <dcterms:modified xsi:type="dcterms:W3CDTF">2016-02-26T14:01:49Z</dcterms:modified>
  <cp:revision>82</cp:revision>
  <dc:subject/>
  <dc:title>PowerPoint Presentation</dc:title>
</cp:coreProperties>
</file>